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2D4D94-7CE1-4322-9C0C-ADBA9B4E2D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F93EF6F-8F51-4319-B91D-AF70A79435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2C98B1-43EE-4F07-8CFD-7B9682B4B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929528-86AB-4E4D-9E01-FAF8108A3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740625-B4AF-4282-B535-0C9750E9B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425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844CDC-517F-4117-88B1-FCE950B4EA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8F335C-D32C-46F7-BE51-6176C82B4B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2F64A9-AD9B-4ED8-8DD1-9A3DB57E3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6D4F73-D221-490B-B34D-7DD4958D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912002-1743-4D68-AAA4-C06EDE7A27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84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270E14-96D0-42D7-B62A-6661212AA7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701F5E-E27D-44C6-B8EE-0A4158F798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233B42-E015-4A39-80C9-33A9D76D69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5DCFD0-A72D-4A68-AFE6-EC56A095F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A689CF-F9DC-4BA6-9274-44C519EF9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418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E6E72A-9700-42A6-A496-F2E9DB9410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51C443-D785-4171-94F8-29B2C7EC12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65D66A-B059-431C-8BD9-045D6A95D0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1A33E8-F068-479F-866E-2ECE82779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B533E4-9208-4AD6-8CEA-7C07E2F54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235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4265A9-1FF8-40A8-8E25-79B5FFC97D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FBD074-C724-4BB8-AE30-D35352AE8C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56535C-E7DC-42F8-A860-6242063C8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21F0BC-438C-413A-A297-12291D201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939D75-CB63-4BEF-BFC6-EF5B12F01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132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8AC4DE-0545-4AF7-B3AD-55B16F757C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DA3BEC-1EDC-40DC-AD03-107E4D9248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768BB7-D110-4363-94B1-9D9C7A79CA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09CE45-181D-4556-927B-8436DAE339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C5DD26-D379-4ADE-8F59-D9E8CD2FE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BF396A-CD68-4B4F-B24B-C34C8B785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709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62B251-0020-4ABC-BD0A-2A6F4249CD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552E8D-3266-47C7-B933-6774C9FEA1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37C067-0DAB-4F26-A064-FD6A21BE12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3C8964-6B9D-4DB3-94A1-6EDCEB2387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887CF2-1D47-4AC5-B8A7-16B2FD68DC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9E6646-D7C6-4CE0-B0C4-AABDBB4FF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A8EC08-21BD-49D7-9723-45A583614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9F8BA5-70F3-40C8-9C24-79B9FE5A22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975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B41BDC-9F66-404F-B2F1-D0B8FA0B1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579261-607D-4922-95EA-58FB86D4D4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D716620-47D4-48F6-B38B-48B56ABDC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2E8DD1-9F54-4342-84F2-CC9F4EBC2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054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20E76D4-AD34-41F9-9C11-B8A9C4E12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B6BC56-4A11-415E-B4E6-E4A1F5303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DB02D8-0F56-4B6D-96A5-CDCB8E2E9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263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EF5571-5DE2-4B5F-8148-AB905A310E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F3EAED-AC47-42D2-941B-CD6657D7D6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A9E1A3-8167-40DD-BCAD-72434A4805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59AE04-5DB2-44BC-8830-E7E57BB89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F29073-54B2-4A34-9B60-6B1EA458F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B48A6D-4A12-4138-9956-24770329DC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54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69E622-01F0-44CB-9805-29C7915AA9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5BCC3F-6684-4505-82B6-9338FDDBC2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380DAC-867F-470E-90A7-A97E51C9C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2DC6E2-AF9B-4BD1-B1EA-8EB24B7D6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8FAA3F-2815-45B3-B9F4-2B1C57320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AA1D2B-A626-46B3-B166-CB9FF534C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390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084E21-1CE1-4F44-84AF-A7A8AD23E7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4D654E-A931-47A5-A6E2-83FA36D372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49A5A5-D729-4F98-B6CB-E10A8F4346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1336DE-FB49-455A-9017-4F093FF5935D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16D232-91E5-4D2F-8645-7BEE0C30C8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584521-3979-43E3-B8C9-94498D2CC5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D39988-8193-4B53-BE3F-7BDC57169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839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150301E-6C47-497C-A1C3-5590D816455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79955" y="85050"/>
            <a:ext cx="4432090" cy="66879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367555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E2DEF5F-27AB-4B72-B961-16C355348A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6701999"/>
              </p:ext>
            </p:extLst>
          </p:nvPr>
        </p:nvGraphicFramePr>
        <p:xfrm>
          <a:off x="838201" y="425323"/>
          <a:ext cx="10515599" cy="307600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80054">
                  <a:extLst>
                    <a:ext uri="{9D8B030D-6E8A-4147-A177-3AD203B41FA5}">
                      <a16:colId xmlns:a16="http://schemas.microsoft.com/office/drawing/2014/main" val="2536042504"/>
                    </a:ext>
                  </a:extLst>
                </a:gridCol>
                <a:gridCol w="1041044">
                  <a:extLst>
                    <a:ext uri="{9D8B030D-6E8A-4147-A177-3AD203B41FA5}">
                      <a16:colId xmlns:a16="http://schemas.microsoft.com/office/drawing/2014/main" val="3761702679"/>
                    </a:ext>
                  </a:extLst>
                </a:gridCol>
                <a:gridCol w="1129375">
                  <a:extLst>
                    <a:ext uri="{9D8B030D-6E8A-4147-A177-3AD203B41FA5}">
                      <a16:colId xmlns:a16="http://schemas.microsoft.com/office/drawing/2014/main" val="1262355938"/>
                    </a:ext>
                  </a:extLst>
                </a:gridCol>
                <a:gridCol w="1604681">
                  <a:extLst>
                    <a:ext uri="{9D8B030D-6E8A-4147-A177-3AD203B41FA5}">
                      <a16:colId xmlns:a16="http://schemas.microsoft.com/office/drawing/2014/main" val="1612660804"/>
                    </a:ext>
                  </a:extLst>
                </a:gridCol>
                <a:gridCol w="1007394">
                  <a:extLst>
                    <a:ext uri="{9D8B030D-6E8A-4147-A177-3AD203B41FA5}">
                      <a16:colId xmlns:a16="http://schemas.microsoft.com/office/drawing/2014/main" val="960067109"/>
                    </a:ext>
                  </a:extLst>
                </a:gridCol>
                <a:gridCol w="2431207">
                  <a:extLst>
                    <a:ext uri="{9D8B030D-6E8A-4147-A177-3AD203B41FA5}">
                      <a16:colId xmlns:a16="http://schemas.microsoft.com/office/drawing/2014/main" val="306662688"/>
                    </a:ext>
                  </a:extLst>
                </a:gridCol>
                <a:gridCol w="2321844">
                  <a:extLst>
                    <a:ext uri="{9D8B030D-6E8A-4147-A177-3AD203B41FA5}">
                      <a16:colId xmlns:a16="http://schemas.microsoft.com/office/drawing/2014/main" val="2720570719"/>
                    </a:ext>
                  </a:extLst>
                </a:gridCol>
              </a:tblGrid>
              <a:tr h="35052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g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 typ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data used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48151961"/>
                  </a:ext>
                </a:extLst>
              </a:tr>
              <a:tr h="35052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56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371E-5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46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regression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, bacterial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10504579"/>
                  </a:ext>
                </a:extLst>
              </a:tr>
              <a:tr h="35052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50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8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494E-5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4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regression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, bacterial, fungal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13060720"/>
                  </a:ext>
                </a:extLst>
              </a:tr>
              <a:tr h="35052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93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99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525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18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regression after logit transformation of data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, bacterial 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63446679"/>
                  </a:ext>
                </a:extLst>
              </a:tr>
              <a:tr h="35052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07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97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530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31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regression after logit transformation of data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, bacterial, fungal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22975377"/>
                  </a:ext>
                </a:extLst>
              </a:tr>
              <a:tr h="35052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6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8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5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oidal model based on logistic growth curv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, bacteria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3120109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2A3B239-D4B3-4ABB-838B-2C2BD839AB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0741495"/>
              </p:ext>
            </p:extLst>
          </p:nvPr>
        </p:nvGraphicFramePr>
        <p:xfrm>
          <a:off x="838200" y="4063419"/>
          <a:ext cx="10515601" cy="187592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027408">
                  <a:extLst>
                    <a:ext uri="{9D8B030D-6E8A-4147-A177-3AD203B41FA5}">
                      <a16:colId xmlns:a16="http://schemas.microsoft.com/office/drawing/2014/main" val="3922970268"/>
                    </a:ext>
                  </a:extLst>
                </a:gridCol>
                <a:gridCol w="2153595">
                  <a:extLst>
                    <a:ext uri="{9D8B030D-6E8A-4147-A177-3AD203B41FA5}">
                      <a16:colId xmlns:a16="http://schemas.microsoft.com/office/drawing/2014/main" val="1492732809"/>
                    </a:ext>
                  </a:extLst>
                </a:gridCol>
                <a:gridCol w="2340773">
                  <a:extLst>
                    <a:ext uri="{9D8B030D-6E8A-4147-A177-3AD203B41FA5}">
                      <a16:colId xmlns:a16="http://schemas.microsoft.com/office/drawing/2014/main" val="3978447922"/>
                    </a:ext>
                  </a:extLst>
                </a:gridCol>
                <a:gridCol w="2090501">
                  <a:extLst>
                    <a:ext uri="{9D8B030D-6E8A-4147-A177-3AD203B41FA5}">
                      <a16:colId xmlns:a16="http://schemas.microsoft.com/office/drawing/2014/main" val="2487381151"/>
                    </a:ext>
                  </a:extLst>
                </a:gridCol>
                <a:gridCol w="1903324">
                  <a:extLst>
                    <a:ext uri="{9D8B030D-6E8A-4147-A177-3AD203B41FA5}">
                      <a16:colId xmlns:a16="http://schemas.microsoft.com/office/drawing/2014/main" val="86167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g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62243546"/>
                  </a:ext>
                </a:extLst>
              </a:tr>
              <a:tr h="3133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96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30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6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39795245"/>
                  </a:ext>
                </a:extLst>
              </a:tr>
              <a:tr h="3133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88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394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756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13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34970432"/>
                  </a:ext>
                </a:extLst>
              </a:tr>
              <a:tr h="3133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10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.633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074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26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72146612"/>
                  </a:ext>
                </a:extLst>
              </a:tr>
              <a:tr h="3133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27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314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.013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47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11728386"/>
                  </a:ext>
                </a:extLst>
              </a:tr>
              <a:tr h="3133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03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8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4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01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18436542"/>
                  </a:ext>
                </a:extLst>
              </a:tr>
            </a:tbl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A72A1FC1-FEE0-4473-947A-644AFF4997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634" y="117546"/>
            <a:ext cx="433132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(A)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395BDEA-FEDB-469F-A383-6C968406421B}"/>
              </a:ext>
            </a:extLst>
          </p:cNvPr>
          <p:cNvSpPr txBox="1"/>
          <p:nvPr/>
        </p:nvSpPr>
        <p:spPr>
          <a:xfrm>
            <a:off x="621634" y="3755642"/>
            <a:ext cx="609460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(B)</a:t>
            </a:r>
            <a:endParaRPr kumimoji="0" lang="en-US" altLang="en-US" sz="20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8581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29</Words>
  <Application>Microsoft Office PowerPoint</Application>
  <PresentationFormat>Widescreen</PresentationFormat>
  <Paragraphs>7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Cho</dc:creator>
  <cp:lastModifiedBy>Matthew Cho</cp:lastModifiedBy>
  <cp:revision>1</cp:revision>
  <dcterms:created xsi:type="dcterms:W3CDTF">2020-09-18T19:41:24Z</dcterms:created>
  <dcterms:modified xsi:type="dcterms:W3CDTF">2020-09-18T19:44:37Z</dcterms:modified>
</cp:coreProperties>
</file>